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25" d="100"/>
          <a:sy n="125" d="100"/>
        </p:scale>
        <p:origin x="1938" y="-46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030FF8-25C6-45EC-AFEB-A08FA9E07572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C770E-63B5-4562-B107-06DFEBB60F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90723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030FF8-25C6-45EC-AFEB-A08FA9E07572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C770E-63B5-4562-B107-06DFEBB60F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20486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030FF8-25C6-45EC-AFEB-A08FA9E07572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C770E-63B5-4562-B107-06DFEBB60F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36237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030FF8-25C6-45EC-AFEB-A08FA9E07572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C770E-63B5-4562-B107-06DFEBB60F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94553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030FF8-25C6-45EC-AFEB-A08FA9E07572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C770E-63B5-4562-B107-06DFEBB60F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305308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030FF8-25C6-45EC-AFEB-A08FA9E07572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C770E-63B5-4562-B107-06DFEBB60F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32066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030FF8-25C6-45EC-AFEB-A08FA9E07572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C770E-63B5-4562-B107-06DFEBB60F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90146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030FF8-25C6-45EC-AFEB-A08FA9E07572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C770E-63B5-4562-B107-06DFEBB60F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68386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030FF8-25C6-45EC-AFEB-A08FA9E07572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C770E-63B5-4562-B107-06DFEBB60F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45243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030FF8-25C6-45EC-AFEB-A08FA9E07572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C770E-63B5-4562-B107-06DFEBB60F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5803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030FF8-25C6-45EC-AFEB-A08FA9E07572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DC770E-63B5-4562-B107-06DFEBB60F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31528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030FF8-25C6-45EC-AFEB-A08FA9E07572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DC770E-63B5-4562-B107-06DFEBB60F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87399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8BF61616-0D5D-C9FB-1C20-FD6705C79E2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2356" y="907916"/>
            <a:ext cx="3953287" cy="9800744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F88FB301-689F-655F-BD70-B799254A6477}"/>
              </a:ext>
            </a:extLst>
          </p:cNvPr>
          <p:cNvSpPr txBox="1"/>
          <p:nvPr/>
        </p:nvSpPr>
        <p:spPr>
          <a:xfrm>
            <a:off x="960118" y="10807030"/>
            <a:ext cx="5364482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6.</a:t>
            </a:r>
            <a:r>
              <a:rPr lang="zh-CN" alt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 Heat map of correlation between gene expression and metabolite abundance</a:t>
            </a:r>
            <a:r>
              <a:rPr lang="en-US" altLang="zh-CN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The top 50 DEGs and DAMs were selected for heatmap analysis using pheatmap packages in R project. </a:t>
            </a:r>
            <a:endParaRPr lang="zh-CN" alt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789412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9</TotalTime>
  <Words>33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靖欣 霍</dc:creator>
  <cp:lastModifiedBy>靖欣 霍</cp:lastModifiedBy>
  <cp:revision>2</cp:revision>
  <dcterms:created xsi:type="dcterms:W3CDTF">2024-06-28T07:03:56Z</dcterms:created>
  <dcterms:modified xsi:type="dcterms:W3CDTF">2024-06-28T07:13:51Z</dcterms:modified>
</cp:coreProperties>
</file>